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359900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1BCE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79" autoAdjust="0"/>
    <p:restoredTop sz="94660"/>
  </p:normalViewPr>
  <p:slideViewPr>
    <p:cSldViewPr snapToGrid="0">
      <p:cViewPr>
        <p:scale>
          <a:sx n="50" d="100"/>
          <a:sy n="50" d="100"/>
        </p:scale>
        <p:origin x="1956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1993" y="1355149"/>
            <a:ext cx="7955915" cy="2882806"/>
          </a:xfrm>
        </p:spPr>
        <p:txBody>
          <a:bodyPr anchor="b"/>
          <a:lstStyle>
            <a:lvl1pPr algn="ctr">
              <a:defRPr sz="6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4349128"/>
            <a:ext cx="7019925" cy="1999179"/>
          </a:xfrm>
        </p:spPr>
        <p:txBody>
          <a:bodyPr/>
          <a:lstStyle>
            <a:lvl1pPr marL="0" indent="0" algn="ctr">
              <a:buNone/>
              <a:defRPr sz="2457"/>
            </a:lvl1pPr>
            <a:lvl2pPr marL="467990" indent="0" algn="ctr">
              <a:buNone/>
              <a:defRPr sz="2047"/>
            </a:lvl2pPr>
            <a:lvl3pPr marL="935980" indent="0" algn="ctr">
              <a:buNone/>
              <a:defRPr sz="1842"/>
            </a:lvl3pPr>
            <a:lvl4pPr marL="1403970" indent="0" algn="ctr">
              <a:buNone/>
              <a:defRPr sz="1638"/>
            </a:lvl4pPr>
            <a:lvl5pPr marL="1871960" indent="0" algn="ctr">
              <a:buNone/>
              <a:defRPr sz="1638"/>
            </a:lvl5pPr>
            <a:lvl6pPr marL="2339950" indent="0" algn="ctr">
              <a:buNone/>
              <a:defRPr sz="1638"/>
            </a:lvl6pPr>
            <a:lvl7pPr marL="2807940" indent="0" algn="ctr">
              <a:buNone/>
              <a:defRPr sz="1638"/>
            </a:lvl7pPr>
            <a:lvl8pPr marL="3275929" indent="0" algn="ctr">
              <a:buNone/>
              <a:defRPr sz="1638"/>
            </a:lvl8pPr>
            <a:lvl9pPr marL="3743919" indent="0" algn="ctr">
              <a:buNone/>
              <a:defRPr sz="163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701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9524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440855"/>
            <a:ext cx="2018228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440855"/>
            <a:ext cx="5937687" cy="70172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0430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062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9" y="2064352"/>
            <a:ext cx="8072914" cy="3444416"/>
          </a:xfrm>
        </p:spPr>
        <p:txBody>
          <a:bodyPr anchor="b"/>
          <a:lstStyle>
            <a:lvl1pPr>
              <a:defRPr sz="6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9" y="5541353"/>
            <a:ext cx="8072914" cy="1811337"/>
          </a:xfrm>
        </p:spPr>
        <p:txBody>
          <a:bodyPr/>
          <a:lstStyle>
            <a:lvl1pPr marL="0" indent="0">
              <a:buNone/>
              <a:defRPr sz="2457">
                <a:solidFill>
                  <a:schemeClr val="tx1"/>
                </a:solidFill>
              </a:defRPr>
            </a:lvl1pPr>
            <a:lvl2pPr marL="467990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2pPr>
            <a:lvl3pPr marL="935980" indent="0">
              <a:buNone/>
              <a:defRPr sz="1842">
                <a:solidFill>
                  <a:schemeClr val="tx1">
                    <a:tint val="75000"/>
                  </a:schemeClr>
                </a:solidFill>
              </a:defRPr>
            </a:lvl3pPr>
            <a:lvl4pPr marL="140397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4pPr>
            <a:lvl5pPr marL="187196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5pPr>
            <a:lvl6pPr marL="233995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6pPr>
            <a:lvl7pPr marL="2807940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7pPr>
            <a:lvl8pPr marL="327592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8pPr>
            <a:lvl9pPr marL="3743919" indent="0">
              <a:buNone/>
              <a:defRPr sz="163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321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2204273"/>
            <a:ext cx="3977958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2204273"/>
            <a:ext cx="3977958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2778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440856"/>
            <a:ext cx="8072914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2029849"/>
            <a:ext cx="3959676" cy="994797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3024646"/>
            <a:ext cx="3959676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50" y="2029849"/>
            <a:ext cx="3979177" cy="994797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50" y="3024646"/>
            <a:ext cx="3979177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8978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446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809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552027"/>
            <a:ext cx="3018811" cy="1932093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1192226"/>
            <a:ext cx="4738449" cy="5884451"/>
          </a:xfrm>
        </p:spPr>
        <p:txBody>
          <a:bodyPr/>
          <a:lstStyle>
            <a:lvl1pPr>
              <a:defRPr sz="3276"/>
            </a:lvl1pPr>
            <a:lvl2pPr>
              <a:defRPr sz="2866"/>
            </a:lvl2pPr>
            <a:lvl3pPr>
              <a:defRPr sz="2457"/>
            </a:lvl3pPr>
            <a:lvl4pPr>
              <a:defRPr sz="2047"/>
            </a:lvl4pPr>
            <a:lvl5pPr>
              <a:defRPr sz="2047"/>
            </a:lvl5pPr>
            <a:lvl6pPr>
              <a:defRPr sz="2047"/>
            </a:lvl6pPr>
            <a:lvl7pPr>
              <a:defRPr sz="2047"/>
            </a:lvl7pPr>
            <a:lvl8pPr>
              <a:defRPr sz="2047"/>
            </a:lvl8pPr>
            <a:lvl9pPr>
              <a:defRPr sz="2047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2484120"/>
            <a:ext cx="3018811" cy="4602140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9089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552027"/>
            <a:ext cx="3018811" cy="1932093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1192226"/>
            <a:ext cx="4738449" cy="5884451"/>
          </a:xfrm>
        </p:spPr>
        <p:txBody>
          <a:bodyPr anchor="t"/>
          <a:lstStyle>
            <a:lvl1pPr marL="0" indent="0">
              <a:buNone/>
              <a:defRPr sz="3276"/>
            </a:lvl1pPr>
            <a:lvl2pPr marL="467990" indent="0">
              <a:buNone/>
              <a:defRPr sz="2866"/>
            </a:lvl2pPr>
            <a:lvl3pPr marL="935980" indent="0">
              <a:buNone/>
              <a:defRPr sz="2457"/>
            </a:lvl3pPr>
            <a:lvl4pPr marL="1403970" indent="0">
              <a:buNone/>
              <a:defRPr sz="2047"/>
            </a:lvl4pPr>
            <a:lvl5pPr marL="1871960" indent="0">
              <a:buNone/>
              <a:defRPr sz="2047"/>
            </a:lvl5pPr>
            <a:lvl6pPr marL="2339950" indent="0">
              <a:buNone/>
              <a:defRPr sz="2047"/>
            </a:lvl6pPr>
            <a:lvl7pPr marL="2807940" indent="0">
              <a:buNone/>
              <a:defRPr sz="2047"/>
            </a:lvl7pPr>
            <a:lvl8pPr marL="3275929" indent="0">
              <a:buNone/>
              <a:defRPr sz="2047"/>
            </a:lvl8pPr>
            <a:lvl9pPr marL="3743919" indent="0">
              <a:buNone/>
              <a:defRPr sz="204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2484120"/>
            <a:ext cx="3018811" cy="4602140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37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440856"/>
            <a:ext cx="8072914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2204273"/>
            <a:ext cx="8072914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7674706"/>
            <a:ext cx="210597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7674706"/>
            <a:ext cx="315896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7674706"/>
            <a:ext cx="210597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7756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35980" rtl="0" eaLnBrk="1" latinLnBrk="0" hangingPunct="1">
        <a:lnSpc>
          <a:spcPct val="90000"/>
        </a:lnSpc>
        <a:spcBef>
          <a:spcPct val="0"/>
        </a:spcBef>
        <a:buNone/>
        <a:defRPr sz="45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3995" indent="-233995" algn="l" defTabSz="935980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2866" kern="1200">
          <a:solidFill>
            <a:schemeClr val="tx1"/>
          </a:solidFill>
          <a:latin typeface="+mn-lt"/>
          <a:ea typeface="+mn-ea"/>
          <a:cs typeface="+mn-cs"/>
        </a:defRPr>
      </a:lvl1pPr>
      <a:lvl2pPr marL="70198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457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047" kern="1200">
          <a:solidFill>
            <a:schemeClr val="tx1"/>
          </a:solidFill>
          <a:latin typeface="+mn-lt"/>
          <a:ea typeface="+mn-ea"/>
          <a:cs typeface="+mn-cs"/>
        </a:defRPr>
      </a:lvl3pPr>
      <a:lvl4pPr marL="163796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210595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57394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304193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50992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97791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93598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3pPr>
      <a:lvl4pPr marL="140397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187196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33995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280794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27592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74391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C21243F9-05BD-427F-B05F-E2EF9865AD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7383" y="4940271"/>
            <a:ext cx="3191256" cy="237116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E3C7AAE-C12A-47D2-B12A-6ABBBCB9A2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4980" y="4969629"/>
            <a:ext cx="3209544" cy="236121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FEFEDEE-9757-4E61-904F-1CEED98DD9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3638" y="792982"/>
            <a:ext cx="3258312" cy="236784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CFF70AF-2653-4DCB-8777-EA54AA237FC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1367" y="769964"/>
            <a:ext cx="3206496" cy="2404324"/>
          </a:xfrm>
          <a:prstGeom prst="rect">
            <a:avLst/>
          </a:prstGeom>
        </p:spPr>
      </p:pic>
      <p:pic>
        <p:nvPicPr>
          <p:cNvPr id="166" name="图片 165">
            <a:extLst>
              <a:ext uri="{FF2B5EF4-FFF2-40B4-BE49-F238E27FC236}">
                <a16:creationId xmlns:a16="http://schemas.microsoft.com/office/drawing/2014/main" id="{BFF65B9A-DD1C-4FD0-B87E-90B405176BA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7097" y="5266761"/>
            <a:ext cx="219332" cy="53496"/>
          </a:xfrm>
          <a:prstGeom prst="rect">
            <a:avLst/>
          </a:prstGeom>
        </p:spPr>
      </p:pic>
      <p:pic>
        <p:nvPicPr>
          <p:cNvPr id="167" name="图片 166">
            <a:extLst>
              <a:ext uri="{FF2B5EF4-FFF2-40B4-BE49-F238E27FC236}">
                <a16:creationId xmlns:a16="http://schemas.microsoft.com/office/drawing/2014/main" id="{FF9512FB-3C55-4815-BA9D-560AC7FDE99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7504" y="5099660"/>
            <a:ext cx="219332" cy="53496"/>
          </a:xfrm>
          <a:prstGeom prst="rect">
            <a:avLst/>
          </a:prstGeom>
        </p:spPr>
      </p:pic>
      <p:sp>
        <p:nvSpPr>
          <p:cNvPr id="168" name="文本框 167">
            <a:extLst>
              <a:ext uri="{FF2B5EF4-FFF2-40B4-BE49-F238E27FC236}">
                <a16:creationId xmlns:a16="http://schemas.microsoft.com/office/drawing/2014/main" id="{B6F7CFCB-59A3-4662-BFBB-60119D27ACA8}"/>
              </a:ext>
            </a:extLst>
          </p:cNvPr>
          <p:cNvSpPr txBox="1"/>
          <p:nvPr/>
        </p:nvSpPr>
        <p:spPr>
          <a:xfrm>
            <a:off x="734457" y="5444285"/>
            <a:ext cx="430887" cy="15847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3C515456-F9D9-4769-9EFB-6BEA73DEE076}"/>
              </a:ext>
            </a:extLst>
          </p:cNvPr>
          <p:cNvSpPr txBox="1"/>
          <p:nvPr/>
        </p:nvSpPr>
        <p:spPr>
          <a:xfrm>
            <a:off x="927881" y="5082488"/>
            <a:ext cx="4470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altLang="zh-CN" sz="4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A8517D77-72A2-40FC-AED3-16660C7F6AB8}"/>
              </a:ext>
            </a:extLst>
          </p:cNvPr>
          <p:cNvSpPr txBox="1"/>
          <p:nvPr/>
        </p:nvSpPr>
        <p:spPr>
          <a:xfrm>
            <a:off x="2152747" y="7563577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OS (Days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D2F07875-5827-4D3A-9E80-98CC2803AE1F}"/>
              </a:ext>
            </a:extLst>
          </p:cNvPr>
          <p:cNvSpPr txBox="1"/>
          <p:nvPr/>
        </p:nvSpPr>
        <p:spPr>
          <a:xfrm>
            <a:off x="1283615" y="7288665"/>
            <a:ext cx="366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             2000          4000          6000          8000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50793055-B12F-4E25-A793-6AD23BCD9740}"/>
              </a:ext>
            </a:extLst>
          </p:cNvPr>
          <p:cNvSpPr txBox="1"/>
          <p:nvPr/>
        </p:nvSpPr>
        <p:spPr>
          <a:xfrm>
            <a:off x="1963887" y="4500102"/>
            <a:ext cx="1847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SE16011 L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F808A772-4B74-4F9F-A38E-53375F8D87E1}"/>
              </a:ext>
            </a:extLst>
          </p:cNvPr>
          <p:cNvSpPr txBox="1"/>
          <p:nvPr/>
        </p:nvSpPr>
        <p:spPr>
          <a:xfrm>
            <a:off x="3210415" y="5005612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ow 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9A4D539E-8BBA-41CE-AEB6-10870C35C19E}"/>
              </a:ext>
            </a:extLst>
          </p:cNvPr>
          <p:cNvSpPr txBox="1"/>
          <p:nvPr/>
        </p:nvSpPr>
        <p:spPr>
          <a:xfrm>
            <a:off x="3210415" y="5178201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igh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F46376B6-791B-4D11-B974-4FBB78A700FC}"/>
              </a:ext>
            </a:extLst>
          </p:cNvPr>
          <p:cNvSpPr txBox="1"/>
          <p:nvPr/>
        </p:nvSpPr>
        <p:spPr>
          <a:xfrm>
            <a:off x="3413894" y="6449702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=0.006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F59BCC3C-C2BE-41BA-B374-0D574372D7F3}"/>
              </a:ext>
            </a:extLst>
          </p:cNvPr>
          <p:cNvSpPr txBox="1"/>
          <p:nvPr/>
        </p:nvSpPr>
        <p:spPr>
          <a:xfrm>
            <a:off x="4918749" y="5627465"/>
            <a:ext cx="430887" cy="15847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82B67DD2-2029-46E8-9E0A-18E73DC497A2}"/>
              </a:ext>
            </a:extLst>
          </p:cNvPr>
          <p:cNvSpPr txBox="1"/>
          <p:nvPr/>
        </p:nvSpPr>
        <p:spPr>
          <a:xfrm>
            <a:off x="5113645" y="5344753"/>
            <a:ext cx="447087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altLang="zh-CN" sz="4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A51CD9F5-197D-4885-A10A-DCBA6074A086}"/>
              </a:ext>
            </a:extLst>
          </p:cNvPr>
          <p:cNvSpPr txBox="1"/>
          <p:nvPr/>
        </p:nvSpPr>
        <p:spPr>
          <a:xfrm>
            <a:off x="6627588" y="7525477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OS (Days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9F9ACD65-C8B7-43BE-A28F-3BD6F8A3D6E5}"/>
              </a:ext>
            </a:extLst>
          </p:cNvPr>
          <p:cNvSpPr txBox="1"/>
          <p:nvPr/>
        </p:nvSpPr>
        <p:spPr>
          <a:xfrm>
            <a:off x="5469378" y="7306127"/>
            <a:ext cx="366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          1000       2000      3000      4000      5000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C9613285-09C9-4855-92C3-76E6D1060257}"/>
              </a:ext>
            </a:extLst>
          </p:cNvPr>
          <p:cNvSpPr txBox="1"/>
          <p:nvPr/>
        </p:nvSpPr>
        <p:spPr>
          <a:xfrm>
            <a:off x="6492550" y="4530264"/>
            <a:ext cx="1885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SE16011 GBM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DBC302A1-A914-45B1-A7A7-0BF4DE998778}"/>
              </a:ext>
            </a:extLst>
          </p:cNvPr>
          <p:cNvSpPr txBox="1"/>
          <p:nvPr/>
        </p:nvSpPr>
        <p:spPr>
          <a:xfrm>
            <a:off x="7396179" y="4997675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ow 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id="{A7211ECA-B07C-4A9F-B4C9-B996528D2714}"/>
              </a:ext>
            </a:extLst>
          </p:cNvPr>
          <p:cNvSpPr txBox="1"/>
          <p:nvPr/>
        </p:nvSpPr>
        <p:spPr>
          <a:xfrm>
            <a:off x="7396179" y="5170264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igh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文本框 185">
            <a:extLst>
              <a:ext uri="{FF2B5EF4-FFF2-40B4-BE49-F238E27FC236}">
                <a16:creationId xmlns:a16="http://schemas.microsoft.com/office/drawing/2014/main" id="{6B3A39EF-8E33-419E-8B95-65B0F3BE9D53}"/>
              </a:ext>
            </a:extLst>
          </p:cNvPr>
          <p:cNvSpPr txBox="1"/>
          <p:nvPr/>
        </p:nvSpPr>
        <p:spPr>
          <a:xfrm>
            <a:off x="7598998" y="6375804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=0.043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F8AB5DA-F6D5-45C6-9DB4-A3AC5326D8F7}"/>
              </a:ext>
            </a:extLst>
          </p:cNvPr>
          <p:cNvSpPr txBox="1"/>
          <p:nvPr/>
        </p:nvSpPr>
        <p:spPr>
          <a:xfrm>
            <a:off x="267702" y="228722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文本框 186">
            <a:extLst>
              <a:ext uri="{FF2B5EF4-FFF2-40B4-BE49-F238E27FC236}">
                <a16:creationId xmlns:a16="http://schemas.microsoft.com/office/drawing/2014/main" id="{456B63E6-4F36-4384-839D-0F232BF8A166}"/>
              </a:ext>
            </a:extLst>
          </p:cNvPr>
          <p:cNvSpPr txBox="1"/>
          <p:nvPr/>
        </p:nvSpPr>
        <p:spPr>
          <a:xfrm>
            <a:off x="250068" y="416462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1708D822-1527-4562-B838-5553DD47ABBD}"/>
              </a:ext>
            </a:extLst>
          </p:cNvPr>
          <p:cNvSpPr txBox="1"/>
          <p:nvPr/>
        </p:nvSpPr>
        <p:spPr>
          <a:xfrm>
            <a:off x="4973804" y="416380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FB2C118F-8FC5-4853-A1A5-CBCA5C2A7F91}"/>
              </a:ext>
            </a:extLst>
          </p:cNvPr>
          <p:cNvSpPr txBox="1"/>
          <p:nvPr/>
        </p:nvSpPr>
        <p:spPr>
          <a:xfrm>
            <a:off x="4994512" y="228721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图片 81">
            <a:extLst>
              <a:ext uri="{FF2B5EF4-FFF2-40B4-BE49-F238E27FC236}">
                <a16:creationId xmlns:a16="http://schemas.microsoft.com/office/drawing/2014/main" id="{AAAE92AF-86E0-4CD1-8F8C-43F9FCD763C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8626" y="5255409"/>
            <a:ext cx="219332" cy="53496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4EB37FBC-DDC3-4CBD-AD07-677A71ECBE5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9033" y="5088308"/>
            <a:ext cx="219332" cy="53496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8871FA41-EBFE-416E-B23B-295E31B04D5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0727" y="1282319"/>
            <a:ext cx="219332" cy="53496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A7E47F65-3725-4C69-9194-9B64D5A4836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1134" y="1115218"/>
            <a:ext cx="219332" cy="53496"/>
          </a:xfrm>
          <a:prstGeom prst="rect">
            <a:avLst/>
          </a:prstGeom>
        </p:spPr>
      </p:pic>
      <p:sp>
        <p:nvSpPr>
          <p:cNvPr id="88" name="文本框 87">
            <a:extLst>
              <a:ext uri="{FF2B5EF4-FFF2-40B4-BE49-F238E27FC236}">
                <a16:creationId xmlns:a16="http://schemas.microsoft.com/office/drawing/2014/main" id="{DE76E36A-3604-41D8-A9A5-9137DE03877D}"/>
              </a:ext>
            </a:extLst>
          </p:cNvPr>
          <p:cNvSpPr txBox="1"/>
          <p:nvPr/>
        </p:nvSpPr>
        <p:spPr>
          <a:xfrm>
            <a:off x="682915" y="1231861"/>
            <a:ext cx="430887" cy="15847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6EA23934-FC6D-49B8-BAE4-46C346B9E874}"/>
              </a:ext>
            </a:extLst>
          </p:cNvPr>
          <p:cNvSpPr txBox="1"/>
          <p:nvPr/>
        </p:nvSpPr>
        <p:spPr>
          <a:xfrm>
            <a:off x="877810" y="956768"/>
            <a:ext cx="4470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altLang="zh-CN" sz="4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5C7E4778-A5C4-4B5A-83BB-C2D3C097E3AD}"/>
              </a:ext>
            </a:extLst>
          </p:cNvPr>
          <p:cNvSpPr txBox="1"/>
          <p:nvPr/>
        </p:nvSpPr>
        <p:spPr>
          <a:xfrm>
            <a:off x="2336652" y="3407351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OS (Days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14054182-342D-40FE-9EA1-9144835E71A6}"/>
              </a:ext>
            </a:extLst>
          </p:cNvPr>
          <p:cNvSpPr txBox="1"/>
          <p:nvPr/>
        </p:nvSpPr>
        <p:spPr>
          <a:xfrm>
            <a:off x="2151032" y="503266"/>
            <a:ext cx="1403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GGA L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1949A7E0-D2CE-4AA7-8138-E41FF12EA4BD}"/>
              </a:ext>
            </a:extLst>
          </p:cNvPr>
          <p:cNvSpPr txBox="1"/>
          <p:nvPr/>
        </p:nvSpPr>
        <p:spPr>
          <a:xfrm>
            <a:off x="3554045" y="1021170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ow 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567E84A1-C0B6-4F0B-9888-85B5FB54F505}"/>
              </a:ext>
            </a:extLst>
          </p:cNvPr>
          <p:cNvSpPr txBox="1"/>
          <p:nvPr/>
        </p:nvSpPr>
        <p:spPr>
          <a:xfrm>
            <a:off x="3554045" y="1193759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igh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8EBFC10C-E61C-47D9-BF18-F25DA03D1AF7}"/>
              </a:ext>
            </a:extLst>
          </p:cNvPr>
          <p:cNvSpPr txBox="1"/>
          <p:nvPr/>
        </p:nvSpPr>
        <p:spPr>
          <a:xfrm>
            <a:off x="3151289" y="2488781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=0.016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7" name="图片 96">
            <a:extLst>
              <a:ext uri="{FF2B5EF4-FFF2-40B4-BE49-F238E27FC236}">
                <a16:creationId xmlns:a16="http://schemas.microsoft.com/office/drawing/2014/main" id="{0E8E5F09-A6C6-4C04-B39C-47651A1598A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1933" y="1315183"/>
            <a:ext cx="219332" cy="53496"/>
          </a:xfrm>
          <a:prstGeom prst="rect">
            <a:avLst/>
          </a:prstGeom>
        </p:spPr>
      </p:pic>
      <p:pic>
        <p:nvPicPr>
          <p:cNvPr id="98" name="图片 97">
            <a:extLst>
              <a:ext uri="{FF2B5EF4-FFF2-40B4-BE49-F238E27FC236}">
                <a16:creationId xmlns:a16="http://schemas.microsoft.com/office/drawing/2014/main" id="{CA372145-51B3-4B15-9E9A-CC8DBC0A8FA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2340" y="1148082"/>
            <a:ext cx="219332" cy="53496"/>
          </a:xfrm>
          <a:prstGeom prst="rect">
            <a:avLst/>
          </a:prstGeom>
        </p:spPr>
      </p:pic>
      <p:sp>
        <p:nvSpPr>
          <p:cNvPr id="99" name="文本框 98">
            <a:extLst>
              <a:ext uri="{FF2B5EF4-FFF2-40B4-BE49-F238E27FC236}">
                <a16:creationId xmlns:a16="http://schemas.microsoft.com/office/drawing/2014/main" id="{0E1485B2-1CA9-404F-95CE-2FAF0FD1206D}"/>
              </a:ext>
            </a:extLst>
          </p:cNvPr>
          <p:cNvSpPr txBox="1"/>
          <p:nvPr/>
        </p:nvSpPr>
        <p:spPr>
          <a:xfrm>
            <a:off x="4919027" y="1226623"/>
            <a:ext cx="430887" cy="15847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AA39B2BD-E680-465C-988D-3BE2ECBF60B1}"/>
              </a:ext>
            </a:extLst>
          </p:cNvPr>
          <p:cNvSpPr txBox="1"/>
          <p:nvPr/>
        </p:nvSpPr>
        <p:spPr>
          <a:xfrm>
            <a:off x="6677969" y="3407234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OS (Days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9551B0A1-EAC7-4000-BF27-0F4E27047DB8}"/>
              </a:ext>
            </a:extLst>
          </p:cNvPr>
          <p:cNvSpPr txBox="1"/>
          <p:nvPr/>
        </p:nvSpPr>
        <p:spPr>
          <a:xfrm>
            <a:off x="6409455" y="498036"/>
            <a:ext cx="1441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GGA GBM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E34AC110-A06D-41FD-B6ED-6EFB881EDAF4}"/>
              </a:ext>
            </a:extLst>
          </p:cNvPr>
          <p:cNvSpPr txBox="1"/>
          <p:nvPr/>
        </p:nvSpPr>
        <p:spPr>
          <a:xfrm>
            <a:off x="7815251" y="1054034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ow 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91D54FEB-28FD-4DDA-B4B9-4C941838F781}"/>
              </a:ext>
            </a:extLst>
          </p:cNvPr>
          <p:cNvSpPr txBox="1"/>
          <p:nvPr/>
        </p:nvSpPr>
        <p:spPr>
          <a:xfrm>
            <a:off x="7815251" y="1226623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igh 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D86B57B0-2930-4024-813D-0BF34507EBFD}"/>
              </a:ext>
            </a:extLst>
          </p:cNvPr>
          <p:cNvSpPr txBox="1"/>
          <p:nvPr/>
        </p:nvSpPr>
        <p:spPr>
          <a:xfrm>
            <a:off x="7547263" y="2219890"/>
            <a:ext cx="1142889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=0.038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E153704E-77BB-448E-B93E-D5615BA1D4A6}"/>
              </a:ext>
            </a:extLst>
          </p:cNvPr>
          <p:cNvSpPr txBox="1"/>
          <p:nvPr/>
        </p:nvSpPr>
        <p:spPr>
          <a:xfrm>
            <a:off x="1244424" y="3132167"/>
            <a:ext cx="366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1000                2000                3000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0D4A4253-E0CB-4C2F-BA15-8D1B3B3BA188}"/>
              </a:ext>
            </a:extLst>
          </p:cNvPr>
          <p:cNvSpPr txBox="1"/>
          <p:nvPr/>
        </p:nvSpPr>
        <p:spPr>
          <a:xfrm>
            <a:off x="5442533" y="3133671"/>
            <a:ext cx="366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 1000               2000                 3000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34698BDD-41D3-4702-957B-85697D7E23DB}"/>
              </a:ext>
            </a:extLst>
          </p:cNvPr>
          <p:cNvSpPr txBox="1"/>
          <p:nvPr/>
        </p:nvSpPr>
        <p:spPr>
          <a:xfrm>
            <a:off x="5134471" y="944390"/>
            <a:ext cx="4470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altLang="zh-CN" sz="4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0233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3</TotalTime>
  <Words>95</Words>
  <Application>Microsoft Office PowerPoint</Application>
  <PresentationFormat>自定义</PresentationFormat>
  <Paragraphs>6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i li</dc:creator>
  <cp:lastModifiedBy>si li</cp:lastModifiedBy>
  <cp:revision>23</cp:revision>
  <dcterms:created xsi:type="dcterms:W3CDTF">2018-04-19T03:25:52Z</dcterms:created>
  <dcterms:modified xsi:type="dcterms:W3CDTF">2018-04-19T15:29:31Z</dcterms:modified>
</cp:coreProperties>
</file>